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1" r:id="rId2"/>
    <p:sldId id="262" r:id="rId3"/>
    <p:sldId id="260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4320" userDrawn="1">
          <p15:clr>
            <a:srgbClr val="A4A3A4"/>
          </p15:clr>
        </p15:guide>
        <p15:guide id="4" orient="horz" pos="3178" userDrawn="1">
          <p15:clr>
            <a:srgbClr val="A4A3A4"/>
          </p15:clr>
        </p15:guide>
        <p15:guide id="5" orient="horz" pos="2618" userDrawn="1">
          <p15:clr>
            <a:srgbClr val="A4A3A4"/>
          </p15:clr>
        </p15:guide>
        <p15:guide id="7" pos="748" userDrawn="1">
          <p15:clr>
            <a:srgbClr val="A4A3A4"/>
          </p15:clr>
        </p15:guide>
        <p15:guide id="8" orient="horz" pos="1706" userDrawn="1">
          <p15:clr>
            <a:srgbClr val="A4A3A4"/>
          </p15:clr>
        </p15:guide>
        <p15:guide id="10" pos="2171" userDrawn="1">
          <p15:clr>
            <a:srgbClr val="A4A3A4"/>
          </p15:clr>
        </p15:guide>
        <p15:guide id="11" pos="3589" userDrawn="1">
          <p15:clr>
            <a:srgbClr val="A4A3A4"/>
          </p15:clr>
        </p15:guide>
        <p15:guide id="12" pos="5012" userDrawn="1">
          <p15:clr>
            <a:srgbClr val="A4A3A4"/>
          </p15:clr>
        </p15:guide>
        <p15:guide id="13" pos="2925" userDrawn="1">
          <p15:clr>
            <a:srgbClr val="A4A3A4"/>
          </p15:clr>
        </p15:guide>
        <p15:guide id="14" orient="horz" pos="1054" userDrawn="1">
          <p15:clr>
            <a:srgbClr val="A4A3A4"/>
          </p15:clr>
        </p15:guide>
        <p15:guide id="15" orient="horz" pos="73" userDrawn="1">
          <p15:clr>
            <a:srgbClr val="A4A3A4"/>
          </p15:clr>
        </p15:guide>
        <p15:guide id="16" orient="horz" pos="996" userDrawn="1">
          <p15:clr>
            <a:srgbClr val="A4A3A4"/>
          </p15:clr>
        </p15:guide>
        <p15:guide id="17" orient="horz" pos="1290" userDrawn="1">
          <p15:clr>
            <a:srgbClr val="A4A3A4"/>
          </p15:clr>
        </p15:guide>
        <p15:guide id="18" orient="horz" pos="1374" userDrawn="1">
          <p15:clr>
            <a:srgbClr val="A4A3A4"/>
          </p15:clr>
        </p15:guide>
        <p15:guide id="19" orient="horz" pos="2326" userDrawn="1">
          <p15:clr>
            <a:srgbClr val="A4A3A4"/>
          </p15:clr>
        </p15:guide>
        <p15:guide id="20" orient="horz" pos="2382" userDrawn="1">
          <p15:clr>
            <a:srgbClr val="A4A3A4"/>
          </p15:clr>
        </p15:guide>
        <p15:guide id="21" orient="horz" pos="3657" userDrawn="1">
          <p15:clr>
            <a:srgbClr val="A4A3A4"/>
          </p15:clr>
        </p15:guide>
        <p15:guide id="22" orient="horz" pos="3712" userDrawn="1">
          <p15:clr>
            <a:srgbClr val="A4A3A4"/>
          </p15:clr>
        </p15:guide>
        <p15:guide id="23" orient="horz" pos="3946" userDrawn="1">
          <p15:clr>
            <a:srgbClr val="A4A3A4"/>
          </p15:clr>
        </p15:guide>
        <p15:guide id="24" orient="horz" pos="1850" userDrawn="1">
          <p15:clr>
            <a:srgbClr val="A4A3A4"/>
          </p15:clr>
        </p15:guide>
        <p15:guide id="25" pos="5692" userDrawn="1">
          <p15:clr>
            <a:srgbClr val="A4A3A4"/>
          </p15:clr>
        </p15:guide>
        <p15:guide id="26" pos="68" userDrawn="1">
          <p15:clr>
            <a:srgbClr val="A4A3A4"/>
          </p15:clr>
        </p15:guide>
        <p15:guide id="27" orient="horz" pos="2702" userDrawn="1">
          <p15:clr>
            <a:srgbClr val="A4A3A4"/>
          </p15:clr>
        </p15:guide>
        <p15:guide id="28" pos="1383" userDrawn="1">
          <p15:clr>
            <a:srgbClr val="A4A3A4"/>
          </p15:clr>
        </p15:guide>
        <p15:guide id="29" pos="42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8DCD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12" autoAdjust="0"/>
    <p:restoredTop sz="94660"/>
  </p:normalViewPr>
  <p:slideViewPr>
    <p:cSldViewPr>
      <p:cViewPr varScale="1">
        <p:scale>
          <a:sx n="84" d="100"/>
          <a:sy n="84" d="100"/>
        </p:scale>
        <p:origin x="1458" y="54"/>
      </p:cViewPr>
      <p:guideLst>
        <p:guide orient="horz" pos="4320"/>
        <p:guide orient="horz" pos="3178"/>
        <p:guide orient="horz" pos="2618"/>
        <p:guide pos="748"/>
        <p:guide orient="horz" pos="1706"/>
        <p:guide pos="2171"/>
        <p:guide pos="3589"/>
        <p:guide pos="5012"/>
        <p:guide pos="2925"/>
        <p:guide orient="horz" pos="1054"/>
        <p:guide orient="horz" pos="73"/>
        <p:guide orient="horz" pos="996"/>
        <p:guide orient="horz" pos="1290"/>
        <p:guide orient="horz" pos="1374"/>
        <p:guide orient="horz" pos="2326"/>
        <p:guide orient="horz" pos="2382"/>
        <p:guide orient="horz" pos="3657"/>
        <p:guide orient="horz" pos="3712"/>
        <p:guide orient="horz" pos="3946"/>
        <p:guide orient="horz" pos="1850"/>
        <p:guide pos="5692"/>
        <p:guide pos="68"/>
        <p:guide orient="horz" pos="2702"/>
        <p:guide pos="1383"/>
        <p:guide pos="428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21FC8-8FF2-4087-91A5-F6DFC78FA461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3423F3-915D-4815-B4B9-F366372F1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62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3423F3-915D-4815-B4B9-F366372F147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6319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microsoft.com/office/2007/relationships/hdphoto" Target="../media/hdphoto6.wdp"/><Relationship Id="rId18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openxmlformats.org/officeDocument/2006/relationships/image" Target="../media/image16.png"/><Relationship Id="rId7" Type="http://schemas.microsoft.com/office/2007/relationships/hdphoto" Target="../media/hdphoto3.wdp"/><Relationship Id="rId12" Type="http://schemas.openxmlformats.org/officeDocument/2006/relationships/image" Target="../media/image11.png"/><Relationship Id="rId17" Type="http://schemas.microsoft.com/office/2007/relationships/hdphoto" Target="../media/hdphoto8.wdp"/><Relationship Id="rId2" Type="http://schemas.openxmlformats.org/officeDocument/2006/relationships/image" Target="../media/image6.png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10.png"/><Relationship Id="rId19" Type="http://schemas.microsoft.com/office/2007/relationships/hdphoto" Target="../media/hdphoto9.wdp"/><Relationship Id="rId4" Type="http://schemas.openxmlformats.org/officeDocument/2006/relationships/image" Target="../media/image7.png"/><Relationship Id="rId9" Type="http://schemas.microsoft.com/office/2007/relationships/hdphoto" Target="../media/hdphoto4.wdp"/><Relationship Id="rId1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2.wdp"/><Relationship Id="rId13" Type="http://schemas.openxmlformats.org/officeDocument/2006/relationships/image" Target="../media/image22.png"/><Relationship Id="rId18" Type="http://schemas.microsoft.com/office/2007/relationships/hdphoto" Target="../media/hdphoto17.wdp"/><Relationship Id="rId3" Type="http://schemas.openxmlformats.org/officeDocument/2006/relationships/image" Target="../media/image17.png"/><Relationship Id="rId21" Type="http://schemas.openxmlformats.org/officeDocument/2006/relationships/image" Target="../media/image26.png"/><Relationship Id="rId7" Type="http://schemas.openxmlformats.org/officeDocument/2006/relationships/image" Target="../media/image19.png"/><Relationship Id="rId12" Type="http://schemas.microsoft.com/office/2007/relationships/hdphoto" Target="../media/hdphoto14.wdp"/><Relationship Id="rId17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6" Type="http://schemas.microsoft.com/office/2007/relationships/hdphoto" Target="../media/hdphoto16.wdp"/><Relationship Id="rId20" Type="http://schemas.microsoft.com/office/2007/relationships/hdphoto" Target="../media/hdphoto18.wdp"/><Relationship Id="rId1" Type="http://schemas.openxmlformats.org/officeDocument/2006/relationships/slideLayout" Target="../slideLayouts/slideLayout1.xml"/><Relationship Id="rId6" Type="http://schemas.microsoft.com/office/2007/relationships/hdphoto" Target="../media/hdphoto11.wdp"/><Relationship Id="rId11" Type="http://schemas.openxmlformats.org/officeDocument/2006/relationships/image" Target="../media/image21.png"/><Relationship Id="rId24" Type="http://schemas.microsoft.com/office/2007/relationships/hdphoto" Target="../media/hdphoto20.wdp"/><Relationship Id="rId5" Type="http://schemas.openxmlformats.org/officeDocument/2006/relationships/image" Target="../media/image18.png"/><Relationship Id="rId15" Type="http://schemas.openxmlformats.org/officeDocument/2006/relationships/image" Target="../media/image23.png"/><Relationship Id="rId23" Type="http://schemas.openxmlformats.org/officeDocument/2006/relationships/image" Target="../media/image27.png"/><Relationship Id="rId10" Type="http://schemas.microsoft.com/office/2007/relationships/hdphoto" Target="../media/hdphoto13.wdp"/><Relationship Id="rId19" Type="http://schemas.openxmlformats.org/officeDocument/2006/relationships/image" Target="../media/image25.png"/><Relationship Id="rId4" Type="http://schemas.microsoft.com/office/2007/relationships/hdphoto" Target="../media/hdphoto10.wdp"/><Relationship Id="rId9" Type="http://schemas.openxmlformats.org/officeDocument/2006/relationships/image" Target="../media/image20.png"/><Relationship Id="rId14" Type="http://schemas.microsoft.com/office/2007/relationships/hdphoto" Target="../media/hdphoto15.wdp"/><Relationship Id="rId22" Type="http://schemas.microsoft.com/office/2007/relationships/hdphoto" Target="../media/hdphoto1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94FF638-DCD1-4B85-B04F-58B78BC535C0}"/>
              </a:ext>
            </a:extLst>
          </p:cNvPr>
          <p:cNvSpPr txBox="1"/>
          <p:nvPr/>
        </p:nvSpPr>
        <p:spPr>
          <a:xfrm rot="16200000">
            <a:off x="1408843" y="507635"/>
            <a:ext cx="9232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31F8919B-7929-4AFD-AFA0-BDC5024AB89B}"/>
              </a:ext>
            </a:extLst>
          </p:cNvPr>
          <p:cNvSpPr txBox="1"/>
          <p:nvPr/>
        </p:nvSpPr>
        <p:spPr>
          <a:xfrm rot="16200000">
            <a:off x="1137079" y="624534"/>
            <a:ext cx="689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0C11D86-DBB3-4C5E-ADD5-5B1B1071E855}"/>
              </a:ext>
            </a:extLst>
          </p:cNvPr>
          <p:cNvSpPr txBox="1"/>
          <p:nvPr/>
        </p:nvSpPr>
        <p:spPr>
          <a:xfrm rot="16200000">
            <a:off x="283550" y="474996"/>
            <a:ext cx="98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Kb 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42F6F07-F686-4DB2-9143-6DFBD2443BA1}"/>
              </a:ext>
            </a:extLst>
          </p:cNvPr>
          <p:cNvSpPr txBox="1"/>
          <p:nvPr/>
        </p:nvSpPr>
        <p:spPr>
          <a:xfrm rot="16200000">
            <a:off x="845138" y="678063"/>
            <a:ext cx="5823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C33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892CD8C-21D8-4935-8307-750285653A52}"/>
              </a:ext>
            </a:extLst>
          </p:cNvPr>
          <p:cNvSpPr txBox="1"/>
          <p:nvPr/>
        </p:nvSpPr>
        <p:spPr>
          <a:xfrm>
            <a:off x="149367" y="2604518"/>
            <a:ext cx="5225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A0918F69-5947-44FE-94BD-3E610C3FD6DE}"/>
              </a:ext>
            </a:extLst>
          </p:cNvPr>
          <p:cNvSpPr txBox="1"/>
          <p:nvPr/>
        </p:nvSpPr>
        <p:spPr>
          <a:xfrm>
            <a:off x="30803" y="2191672"/>
            <a:ext cx="641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60F61BC-9B81-4C49-808C-84FB4C769733}"/>
              </a:ext>
            </a:extLst>
          </p:cNvPr>
          <p:cNvSpPr txBox="1"/>
          <p:nvPr/>
        </p:nvSpPr>
        <p:spPr>
          <a:xfrm>
            <a:off x="94888" y="2448660"/>
            <a:ext cx="577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AE38DE2-87A5-4AED-8963-9D987E34DBC7}"/>
              </a:ext>
            </a:extLst>
          </p:cNvPr>
          <p:cNvSpPr txBox="1"/>
          <p:nvPr/>
        </p:nvSpPr>
        <p:spPr>
          <a:xfrm>
            <a:off x="213452" y="2325174"/>
            <a:ext cx="4584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0E27CB6-53A5-4B09-9A5A-65D1592B1202}"/>
              </a:ext>
            </a:extLst>
          </p:cNvPr>
          <p:cNvSpPr txBox="1"/>
          <p:nvPr/>
        </p:nvSpPr>
        <p:spPr>
          <a:xfrm>
            <a:off x="100797" y="1761726"/>
            <a:ext cx="5711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6A4F6273-2789-4F09-B0CE-6562A8BEC626}"/>
              </a:ext>
            </a:extLst>
          </p:cNvPr>
          <p:cNvSpPr txBox="1"/>
          <p:nvPr/>
        </p:nvSpPr>
        <p:spPr>
          <a:xfrm>
            <a:off x="30803" y="1432135"/>
            <a:ext cx="641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4C2670CC-885E-494C-A3CE-644BC8FFBE8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64" t="26002" r="16645" b="54909"/>
          <a:stretch/>
        </p:blipFill>
        <p:spPr>
          <a:xfrm>
            <a:off x="619125" y="1028701"/>
            <a:ext cx="1414628" cy="2000250"/>
          </a:xfrm>
          <a:prstGeom prst="rect">
            <a:avLst/>
          </a:prstGeom>
          <a:ln w="88900" cap="sq" cmpd="thickThin">
            <a:noFill/>
            <a:prstDash val="solid"/>
            <a:miter lim="800000"/>
          </a:ln>
          <a:effectLst>
            <a:innerShdw blurRad="76200">
              <a:srgbClr val="000000"/>
            </a:innerShdw>
          </a:effectLst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7A044DF0-04A8-410E-8F5A-7EB3A52C02B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70" t="74004" r="8749" b="2867"/>
          <a:stretch/>
        </p:blipFill>
        <p:spPr>
          <a:xfrm>
            <a:off x="2971800" y="889889"/>
            <a:ext cx="1847850" cy="2143750"/>
          </a:xfrm>
          <a:prstGeom prst="rect">
            <a:avLst/>
          </a:prstGeom>
          <a:ln w="88900" cap="sq" cmpd="thickThin">
            <a:noFill/>
            <a:prstDash val="solid"/>
            <a:miter lim="800000"/>
          </a:ln>
          <a:effectLst>
            <a:innerShdw blurRad="76200">
              <a:srgbClr val="000000"/>
            </a:innerShdw>
          </a:effec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FE9B2025-66DD-4711-B57F-050C3305BC25}"/>
              </a:ext>
            </a:extLst>
          </p:cNvPr>
          <p:cNvSpPr txBox="1"/>
          <p:nvPr/>
        </p:nvSpPr>
        <p:spPr>
          <a:xfrm rot="16200000">
            <a:off x="3894065" y="395102"/>
            <a:ext cx="902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7BFE31F-57F4-49C8-84AC-47B3D2693673}"/>
              </a:ext>
            </a:extLst>
          </p:cNvPr>
          <p:cNvSpPr txBox="1"/>
          <p:nvPr/>
        </p:nvSpPr>
        <p:spPr>
          <a:xfrm rot="16200000">
            <a:off x="3671293" y="488307"/>
            <a:ext cx="7163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8ABC8A5E-C107-4B49-8EBD-DB99DD0F5FA9}"/>
              </a:ext>
            </a:extLst>
          </p:cNvPr>
          <p:cNvSpPr txBox="1"/>
          <p:nvPr/>
        </p:nvSpPr>
        <p:spPr>
          <a:xfrm rot="16200000">
            <a:off x="4201677" y="411750"/>
            <a:ext cx="869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2C755BE5-AA24-4F96-995F-582F229B49A4}"/>
              </a:ext>
            </a:extLst>
          </p:cNvPr>
          <p:cNvSpPr txBox="1"/>
          <p:nvPr/>
        </p:nvSpPr>
        <p:spPr>
          <a:xfrm rot="16200000">
            <a:off x="3263801" y="378439"/>
            <a:ext cx="936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476BAD39-8EB4-4CF3-9333-20C8BE140FC9}"/>
              </a:ext>
            </a:extLst>
          </p:cNvPr>
          <p:cNvSpPr txBox="1"/>
          <p:nvPr/>
        </p:nvSpPr>
        <p:spPr>
          <a:xfrm rot="16200000">
            <a:off x="2586238" y="292079"/>
            <a:ext cx="1108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p Ladde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9A58EAEC-B5C0-40C7-A293-7C0217E87242}"/>
              </a:ext>
            </a:extLst>
          </p:cNvPr>
          <p:cNvSpPr txBox="1"/>
          <p:nvPr/>
        </p:nvSpPr>
        <p:spPr>
          <a:xfrm rot="16200000">
            <a:off x="3019725" y="431988"/>
            <a:ext cx="82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C33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76BB49B-96C3-4D93-A29C-8544C464153F}"/>
              </a:ext>
            </a:extLst>
          </p:cNvPr>
          <p:cNvSpPr txBox="1"/>
          <p:nvPr/>
        </p:nvSpPr>
        <p:spPr>
          <a:xfrm>
            <a:off x="2659093" y="2600576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3B775BD5-ABA6-46AD-8BA1-0FE2B8219DFB}"/>
              </a:ext>
            </a:extLst>
          </p:cNvPr>
          <p:cNvSpPr txBox="1"/>
          <p:nvPr/>
        </p:nvSpPr>
        <p:spPr>
          <a:xfrm>
            <a:off x="2638651" y="2475992"/>
            <a:ext cx="402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0D26A943-79FE-47D7-B7D5-61E45EA64D13}"/>
              </a:ext>
            </a:extLst>
          </p:cNvPr>
          <p:cNvSpPr txBox="1"/>
          <p:nvPr/>
        </p:nvSpPr>
        <p:spPr>
          <a:xfrm>
            <a:off x="2659093" y="2360576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89D13E31-2ECE-40DA-847E-3613639F3C72}"/>
              </a:ext>
            </a:extLst>
          </p:cNvPr>
          <p:cNvSpPr txBox="1"/>
          <p:nvPr/>
        </p:nvSpPr>
        <p:spPr>
          <a:xfrm>
            <a:off x="2572015" y="2245160"/>
            <a:ext cx="469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603363EA-3645-4204-85B8-D0EB48A71755}"/>
              </a:ext>
            </a:extLst>
          </p:cNvPr>
          <p:cNvSpPr txBox="1"/>
          <p:nvPr/>
        </p:nvSpPr>
        <p:spPr>
          <a:xfrm>
            <a:off x="2659093" y="2111818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B82A2D03-C230-4004-AB8C-93FDB223C240}"/>
              </a:ext>
            </a:extLst>
          </p:cNvPr>
          <p:cNvSpPr txBox="1"/>
          <p:nvPr/>
        </p:nvSpPr>
        <p:spPr>
          <a:xfrm>
            <a:off x="2506693" y="1702820"/>
            <a:ext cx="534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2B79CA4F-D049-4353-925A-78CC8B7B6E72}"/>
              </a:ext>
            </a:extLst>
          </p:cNvPr>
          <p:cNvSpPr txBox="1"/>
          <p:nvPr/>
        </p:nvSpPr>
        <p:spPr>
          <a:xfrm>
            <a:off x="2659093" y="199891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D5EF7421-1F34-4893-AA2B-7518F5CD9181}"/>
              </a:ext>
            </a:extLst>
          </p:cNvPr>
          <p:cNvSpPr txBox="1"/>
          <p:nvPr/>
        </p:nvSpPr>
        <p:spPr>
          <a:xfrm>
            <a:off x="2659093" y="1868391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8A0CF80F-FEB1-460B-B2A1-AB15105E7327}"/>
              </a:ext>
            </a:extLst>
          </p:cNvPr>
          <p:cNvSpPr txBox="1"/>
          <p:nvPr/>
        </p:nvSpPr>
        <p:spPr>
          <a:xfrm>
            <a:off x="2565095" y="1504217"/>
            <a:ext cx="4765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6D9939CA-1DBA-4CB3-AE9E-E40907CE0A9F}"/>
              </a:ext>
            </a:extLst>
          </p:cNvPr>
          <p:cNvSpPr txBox="1"/>
          <p:nvPr/>
        </p:nvSpPr>
        <p:spPr>
          <a:xfrm>
            <a:off x="2603343" y="1270064"/>
            <a:ext cx="438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256454F2-CFA0-4037-993A-C2D90812D1AE}"/>
              </a:ext>
            </a:extLst>
          </p:cNvPr>
          <p:cNvSpPr txBox="1"/>
          <p:nvPr/>
        </p:nvSpPr>
        <p:spPr>
          <a:xfrm>
            <a:off x="4905111" y="2174747"/>
            <a:ext cx="731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smtClean="0">
                <a:latin typeface="Arial" panose="020B0604020202020204" pitchFamily="34" charset="0"/>
                <a:cs typeface="Arial" panose="020B0604020202020204" pitchFamily="34" charset="0"/>
              </a:rPr>
              <a:t>436bp </a:t>
            </a:r>
            <a:endParaRPr lang="en-I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302E8776-1F84-4AA1-A230-286012987680}"/>
              </a:ext>
            </a:extLst>
          </p:cNvPr>
          <p:cNvSpPr txBox="1"/>
          <p:nvPr/>
        </p:nvSpPr>
        <p:spPr>
          <a:xfrm flipV="1">
            <a:off x="4806905" y="2173224"/>
            <a:ext cx="2498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►</a:t>
            </a:r>
            <a:endParaRPr lang="en-US" sz="11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F233E51D-4640-48DA-83D1-DF9B644BBCF3}"/>
              </a:ext>
            </a:extLst>
          </p:cNvPr>
          <p:cNvSpPr txBox="1"/>
          <p:nvPr/>
        </p:nvSpPr>
        <p:spPr>
          <a:xfrm rot="16200000">
            <a:off x="1230443" y="3560884"/>
            <a:ext cx="932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045BF9D1-A5AA-491D-9A70-C6AA2D797FE5}"/>
              </a:ext>
            </a:extLst>
          </p:cNvPr>
          <p:cNvSpPr txBox="1"/>
          <p:nvPr/>
        </p:nvSpPr>
        <p:spPr>
          <a:xfrm rot="16200000">
            <a:off x="985609" y="3632597"/>
            <a:ext cx="790176" cy="251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D1226BF2-C0F7-4D72-B2D9-703EB26B1BC3}"/>
              </a:ext>
            </a:extLst>
          </p:cNvPr>
          <p:cNvSpPr txBox="1"/>
          <p:nvPr/>
        </p:nvSpPr>
        <p:spPr>
          <a:xfrm rot="16200000">
            <a:off x="1557477" y="3600038"/>
            <a:ext cx="860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A64615B0-CA9D-4D7A-97F6-8BAB262992C2}"/>
              </a:ext>
            </a:extLst>
          </p:cNvPr>
          <p:cNvSpPr txBox="1"/>
          <p:nvPr/>
        </p:nvSpPr>
        <p:spPr>
          <a:xfrm rot="16200000">
            <a:off x="654454" y="3595984"/>
            <a:ext cx="857238" cy="251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23BBED96-9486-4DDB-8B67-DC6055F94426}"/>
              </a:ext>
            </a:extLst>
          </p:cNvPr>
          <p:cNvSpPr txBox="1"/>
          <p:nvPr/>
        </p:nvSpPr>
        <p:spPr>
          <a:xfrm rot="16200000">
            <a:off x="-65613" y="3463324"/>
            <a:ext cx="1114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p Ladder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5ED57BA2-2F41-4BB3-AA2D-4F3F29C3FC82}"/>
              </a:ext>
            </a:extLst>
          </p:cNvPr>
          <p:cNvSpPr txBox="1"/>
          <p:nvPr/>
        </p:nvSpPr>
        <p:spPr>
          <a:xfrm rot="16200000">
            <a:off x="405866" y="3649533"/>
            <a:ext cx="759164" cy="251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C33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12318F45-E282-44F8-B7CF-7FC14B42DF3A}"/>
              </a:ext>
            </a:extLst>
          </p:cNvPr>
          <p:cNvSpPr txBox="1"/>
          <p:nvPr/>
        </p:nvSpPr>
        <p:spPr>
          <a:xfrm>
            <a:off x="6394" y="5782734"/>
            <a:ext cx="390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503BBC4A-2B30-4D54-8546-B535D3D8ECA7}"/>
              </a:ext>
            </a:extLst>
          </p:cNvPr>
          <p:cNvSpPr txBox="1"/>
          <p:nvPr/>
        </p:nvSpPr>
        <p:spPr>
          <a:xfrm>
            <a:off x="-14257" y="5543850"/>
            <a:ext cx="411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C15A5E12-EA24-4E4A-BD63-B81E178AE042}"/>
              </a:ext>
            </a:extLst>
          </p:cNvPr>
          <p:cNvSpPr txBox="1"/>
          <p:nvPr/>
        </p:nvSpPr>
        <p:spPr>
          <a:xfrm>
            <a:off x="6394" y="5428434"/>
            <a:ext cx="390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F7A6F6E5-D9B2-4AE5-8678-032A0BA89957}"/>
              </a:ext>
            </a:extLst>
          </p:cNvPr>
          <p:cNvSpPr txBox="1"/>
          <p:nvPr/>
        </p:nvSpPr>
        <p:spPr>
          <a:xfrm>
            <a:off x="-81574" y="5313018"/>
            <a:ext cx="4792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5A89CDB8-5397-42E4-806D-4F9C3CBB70F3}"/>
              </a:ext>
            </a:extLst>
          </p:cNvPr>
          <p:cNvSpPr txBox="1"/>
          <p:nvPr/>
        </p:nvSpPr>
        <p:spPr>
          <a:xfrm>
            <a:off x="6394" y="5179676"/>
            <a:ext cx="390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629607DF-7B3B-47DF-9522-A76A0DD7C1CC}"/>
              </a:ext>
            </a:extLst>
          </p:cNvPr>
          <p:cNvSpPr txBox="1"/>
          <p:nvPr/>
        </p:nvSpPr>
        <p:spPr>
          <a:xfrm>
            <a:off x="-147563" y="4770678"/>
            <a:ext cx="5458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F07346AA-C1B0-4483-BA93-3520C1B5A1F3}"/>
              </a:ext>
            </a:extLst>
          </p:cNvPr>
          <p:cNvSpPr txBox="1"/>
          <p:nvPr/>
        </p:nvSpPr>
        <p:spPr>
          <a:xfrm>
            <a:off x="6394" y="5066771"/>
            <a:ext cx="390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BC66FF77-6BCA-4FDE-9167-CD722C597CD5}"/>
              </a:ext>
            </a:extLst>
          </p:cNvPr>
          <p:cNvSpPr txBox="1"/>
          <p:nvPr/>
        </p:nvSpPr>
        <p:spPr>
          <a:xfrm>
            <a:off x="6394" y="4936249"/>
            <a:ext cx="390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9031D127-C424-416E-B045-B6A8D52CD4DC}"/>
              </a:ext>
            </a:extLst>
          </p:cNvPr>
          <p:cNvSpPr txBox="1"/>
          <p:nvPr/>
        </p:nvSpPr>
        <p:spPr>
          <a:xfrm>
            <a:off x="-88564" y="4572075"/>
            <a:ext cx="486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0B906A32-1F43-4A15-8791-A8A11694E931}"/>
              </a:ext>
            </a:extLst>
          </p:cNvPr>
          <p:cNvSpPr txBox="1"/>
          <p:nvPr/>
        </p:nvSpPr>
        <p:spPr>
          <a:xfrm>
            <a:off x="-49926" y="4388722"/>
            <a:ext cx="4472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2772CBCB-657F-4034-9411-4C96BFED4330}"/>
              </a:ext>
            </a:extLst>
          </p:cNvPr>
          <p:cNvSpPr txBox="1"/>
          <p:nvPr/>
        </p:nvSpPr>
        <p:spPr>
          <a:xfrm>
            <a:off x="2252511" y="5247729"/>
            <a:ext cx="74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50bp</a:t>
            </a:r>
          </a:p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 L1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B0075007-6F14-4EE6-AE8F-9CA6C61FE1B0}"/>
              </a:ext>
            </a:extLst>
          </p:cNvPr>
          <p:cNvSpPr txBox="1"/>
          <p:nvPr/>
        </p:nvSpPr>
        <p:spPr>
          <a:xfrm flipV="1">
            <a:off x="2170532" y="5241667"/>
            <a:ext cx="2549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►</a:t>
            </a:r>
            <a:endParaRPr lang="en-US" sz="1100" dirty="0"/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xmlns="" id="{8AA1DBA6-6376-4968-AF88-F685E4E5630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0" t="67679" r="24462" b="7525"/>
          <a:stretch/>
        </p:blipFill>
        <p:spPr>
          <a:xfrm>
            <a:off x="320748" y="4097222"/>
            <a:ext cx="1893032" cy="2249898"/>
          </a:xfrm>
          <a:prstGeom prst="rect">
            <a:avLst/>
          </a:prstGeom>
          <a:ln w="88900" cap="sq" cmpd="thickThin">
            <a:noFill/>
            <a:prstDash val="solid"/>
            <a:miter lim="800000"/>
          </a:ln>
          <a:effectLst>
            <a:innerShdw blurRad="76200">
              <a:srgbClr val="000000"/>
            </a:innerShdw>
          </a:effectLst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F0F55B52-C0AB-4E00-860A-85184CD96E70}"/>
              </a:ext>
            </a:extLst>
          </p:cNvPr>
          <p:cNvSpPr txBox="1"/>
          <p:nvPr/>
        </p:nvSpPr>
        <p:spPr>
          <a:xfrm rot="16200000">
            <a:off x="4100512" y="3586767"/>
            <a:ext cx="984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2885306A-C5A9-4BFC-8F74-7152F763BD2A}"/>
              </a:ext>
            </a:extLst>
          </p:cNvPr>
          <p:cNvSpPr txBox="1"/>
          <p:nvPr/>
        </p:nvSpPr>
        <p:spPr>
          <a:xfrm rot="16200000">
            <a:off x="4028266" y="3830496"/>
            <a:ext cx="4967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92ACDBFC-BC8A-488A-A9FA-98A1DCC4C895}"/>
              </a:ext>
            </a:extLst>
          </p:cNvPr>
          <p:cNvSpPr txBox="1"/>
          <p:nvPr/>
        </p:nvSpPr>
        <p:spPr>
          <a:xfrm rot="16200000">
            <a:off x="4462222" y="3657511"/>
            <a:ext cx="842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28CFFAF3-5F65-49EF-AC59-F9CB77D97D55}"/>
              </a:ext>
            </a:extLst>
          </p:cNvPr>
          <p:cNvSpPr txBox="1"/>
          <p:nvPr/>
        </p:nvSpPr>
        <p:spPr>
          <a:xfrm rot="16200000">
            <a:off x="3730641" y="3830496"/>
            <a:ext cx="496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09E4DF6D-956B-4864-B53D-7394AF8C3FCD}"/>
              </a:ext>
            </a:extLst>
          </p:cNvPr>
          <p:cNvSpPr txBox="1"/>
          <p:nvPr/>
        </p:nvSpPr>
        <p:spPr>
          <a:xfrm rot="16200000">
            <a:off x="2791168" y="3482225"/>
            <a:ext cx="1193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p Ladder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3C361E28-C3F4-4EE5-9310-7684D0FF249C}"/>
              </a:ext>
            </a:extLst>
          </p:cNvPr>
          <p:cNvSpPr txBox="1"/>
          <p:nvPr/>
        </p:nvSpPr>
        <p:spPr>
          <a:xfrm rot="16200000">
            <a:off x="3143573" y="3541055"/>
            <a:ext cx="1075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0F601098-C94D-4616-941F-4F06918588A5}"/>
              </a:ext>
            </a:extLst>
          </p:cNvPr>
          <p:cNvSpPr txBox="1"/>
          <p:nvPr/>
        </p:nvSpPr>
        <p:spPr>
          <a:xfrm>
            <a:off x="2904691" y="5734501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F41AD7CC-7674-46CE-94EF-98CBF19D572B}"/>
              </a:ext>
            </a:extLst>
          </p:cNvPr>
          <p:cNvSpPr txBox="1"/>
          <p:nvPr/>
        </p:nvSpPr>
        <p:spPr>
          <a:xfrm>
            <a:off x="2884249" y="5636198"/>
            <a:ext cx="402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B7F3BB27-F1D1-4CE7-B454-07E1AB29DE02}"/>
              </a:ext>
            </a:extLst>
          </p:cNvPr>
          <p:cNvSpPr txBox="1"/>
          <p:nvPr/>
        </p:nvSpPr>
        <p:spPr>
          <a:xfrm>
            <a:off x="2904691" y="549687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99477D97-9D29-48C7-95DB-84F48602F9CD}"/>
              </a:ext>
            </a:extLst>
          </p:cNvPr>
          <p:cNvSpPr txBox="1"/>
          <p:nvPr/>
        </p:nvSpPr>
        <p:spPr>
          <a:xfrm>
            <a:off x="2817613" y="5381171"/>
            <a:ext cx="469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516D1431-B353-4AB3-A0D7-BFAF0909D1A0}"/>
              </a:ext>
            </a:extLst>
          </p:cNvPr>
          <p:cNvSpPr txBox="1"/>
          <p:nvPr/>
        </p:nvSpPr>
        <p:spPr>
          <a:xfrm>
            <a:off x="2904691" y="527417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E3FBCB33-46CB-4821-AD57-138FEC1D92CA}"/>
              </a:ext>
            </a:extLst>
          </p:cNvPr>
          <p:cNvSpPr txBox="1"/>
          <p:nvPr/>
        </p:nvSpPr>
        <p:spPr>
          <a:xfrm>
            <a:off x="2752291" y="4929792"/>
            <a:ext cx="534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C6B2C16E-1B96-4300-A0D5-4BDE2BBDD0C3}"/>
              </a:ext>
            </a:extLst>
          </p:cNvPr>
          <p:cNvSpPr txBox="1"/>
          <p:nvPr/>
        </p:nvSpPr>
        <p:spPr>
          <a:xfrm>
            <a:off x="2904691" y="5157940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3A1AF45C-5806-4D41-840F-C8AEE3AC8027}"/>
              </a:ext>
            </a:extLst>
          </p:cNvPr>
          <p:cNvSpPr txBox="1"/>
          <p:nvPr/>
        </p:nvSpPr>
        <p:spPr>
          <a:xfrm>
            <a:off x="2904691" y="5040075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78AAC26E-1167-4297-8507-36B61EDBECE1}"/>
              </a:ext>
            </a:extLst>
          </p:cNvPr>
          <p:cNvSpPr txBox="1"/>
          <p:nvPr/>
        </p:nvSpPr>
        <p:spPr>
          <a:xfrm>
            <a:off x="2798097" y="4789819"/>
            <a:ext cx="489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78976F1B-7BC4-499E-B8F5-42E317FD8D8A}"/>
              </a:ext>
            </a:extLst>
          </p:cNvPr>
          <p:cNvSpPr txBox="1"/>
          <p:nvPr/>
        </p:nvSpPr>
        <p:spPr>
          <a:xfrm>
            <a:off x="2848941" y="4550469"/>
            <a:ext cx="438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5998C735-26E8-4545-85CD-70BA642EFC7F}"/>
              </a:ext>
            </a:extLst>
          </p:cNvPr>
          <p:cNvSpPr txBox="1"/>
          <p:nvPr/>
        </p:nvSpPr>
        <p:spPr>
          <a:xfrm>
            <a:off x="5207188" y="5284481"/>
            <a:ext cx="872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3bp </a:t>
            </a:r>
            <a:endParaRPr lang="en-I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HPV16 E6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DCACB973-4EF0-4D31-9F68-9435059B093C}"/>
              </a:ext>
            </a:extLst>
          </p:cNvPr>
          <p:cNvSpPr txBox="1"/>
          <p:nvPr/>
        </p:nvSpPr>
        <p:spPr>
          <a:xfrm flipV="1">
            <a:off x="5112302" y="5276786"/>
            <a:ext cx="2498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►</a:t>
            </a:r>
            <a:endParaRPr lang="en-US" sz="1100" dirty="0"/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xmlns="" id="{2882F51A-A380-48A2-B791-24489B29262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53" t="46179" r="23348" b="27021"/>
          <a:stretch/>
        </p:blipFill>
        <p:spPr>
          <a:xfrm>
            <a:off x="3229092" y="4121125"/>
            <a:ext cx="1883210" cy="2220362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xmlns="" id="{D7167A74-5B02-4567-9697-ACA25F82E99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98" t="35269" r="6296" b="42258"/>
          <a:stretch/>
        </p:blipFill>
        <p:spPr>
          <a:xfrm>
            <a:off x="6467475" y="4343399"/>
            <a:ext cx="1790700" cy="1996701"/>
          </a:xfrm>
          <a:prstGeom prst="rect">
            <a:avLst/>
          </a:prstGeom>
          <a:ln w="88900" cap="sq" cmpd="thickThin">
            <a:noFill/>
            <a:prstDash val="solid"/>
            <a:miter lim="800000"/>
          </a:ln>
          <a:effectLst>
            <a:innerShdw blurRad="76200">
              <a:srgbClr val="000000"/>
            </a:innerShdw>
          </a:effectLst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D95EAB89-22D8-49B8-AF98-0961B5FF7213}"/>
              </a:ext>
            </a:extLst>
          </p:cNvPr>
          <p:cNvSpPr txBox="1"/>
          <p:nvPr/>
        </p:nvSpPr>
        <p:spPr>
          <a:xfrm rot="16200000">
            <a:off x="7380890" y="3858375"/>
            <a:ext cx="862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4B2B5C6F-BE32-4DA4-AE5A-DADBF371E709}"/>
              </a:ext>
            </a:extLst>
          </p:cNvPr>
          <p:cNvSpPr txBox="1"/>
          <p:nvPr/>
        </p:nvSpPr>
        <p:spPr>
          <a:xfrm rot="16200000">
            <a:off x="7249753" y="4043215"/>
            <a:ext cx="493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7FC1B6D5-A2A9-491C-B7DE-185F02D4E210}"/>
              </a:ext>
            </a:extLst>
          </p:cNvPr>
          <p:cNvSpPr txBox="1"/>
          <p:nvPr/>
        </p:nvSpPr>
        <p:spPr>
          <a:xfrm rot="16200000">
            <a:off x="7671854" y="3858374"/>
            <a:ext cx="862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28E0C08F-0F72-4AF6-A44C-2A037F1A8877}"/>
              </a:ext>
            </a:extLst>
          </p:cNvPr>
          <p:cNvSpPr txBox="1"/>
          <p:nvPr/>
        </p:nvSpPr>
        <p:spPr>
          <a:xfrm rot="16200000">
            <a:off x="6952128" y="4043214"/>
            <a:ext cx="493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99B64658-4FDC-4219-80A2-545848C5F4B0}"/>
              </a:ext>
            </a:extLst>
          </p:cNvPr>
          <p:cNvSpPr txBox="1"/>
          <p:nvPr/>
        </p:nvSpPr>
        <p:spPr>
          <a:xfrm rot="16200000">
            <a:off x="6032373" y="3714662"/>
            <a:ext cx="1150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p Ladder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116D3BF6-A406-4381-B342-8C9D84D40464}"/>
              </a:ext>
            </a:extLst>
          </p:cNvPr>
          <p:cNvSpPr txBox="1"/>
          <p:nvPr/>
        </p:nvSpPr>
        <p:spPr>
          <a:xfrm rot="16200000">
            <a:off x="6486598" y="3875310"/>
            <a:ext cx="82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C33a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638FF35C-8041-4D6B-A655-B6BBCD043A0C}"/>
              </a:ext>
            </a:extLst>
          </p:cNvPr>
          <p:cNvSpPr txBox="1"/>
          <p:nvPr/>
        </p:nvSpPr>
        <p:spPr>
          <a:xfrm>
            <a:off x="6124400" y="5840670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6FDBBC01-6A24-4C80-9288-9863C8F0F0FA}"/>
              </a:ext>
            </a:extLst>
          </p:cNvPr>
          <p:cNvSpPr txBox="1"/>
          <p:nvPr/>
        </p:nvSpPr>
        <p:spPr>
          <a:xfrm>
            <a:off x="6103958" y="5742367"/>
            <a:ext cx="4029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930C6EED-2207-4DF5-8ABA-D5A407074235}"/>
              </a:ext>
            </a:extLst>
          </p:cNvPr>
          <p:cNvSpPr txBox="1"/>
          <p:nvPr/>
        </p:nvSpPr>
        <p:spPr>
          <a:xfrm>
            <a:off x="6124400" y="5603042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99CDE918-7699-4E6A-A69B-3D14C1C00811}"/>
              </a:ext>
            </a:extLst>
          </p:cNvPr>
          <p:cNvSpPr txBox="1"/>
          <p:nvPr/>
        </p:nvSpPr>
        <p:spPr>
          <a:xfrm>
            <a:off x="6037322" y="5487340"/>
            <a:ext cx="469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A0975CCC-4BBD-464B-A20F-0CBD22D45E71}"/>
              </a:ext>
            </a:extLst>
          </p:cNvPr>
          <p:cNvSpPr txBox="1"/>
          <p:nvPr/>
        </p:nvSpPr>
        <p:spPr>
          <a:xfrm>
            <a:off x="6124400" y="536605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CBFDB654-9C04-4C31-AC25-C5430B1808AF}"/>
              </a:ext>
            </a:extLst>
          </p:cNvPr>
          <p:cNvSpPr txBox="1"/>
          <p:nvPr/>
        </p:nvSpPr>
        <p:spPr>
          <a:xfrm>
            <a:off x="5972000" y="5021672"/>
            <a:ext cx="534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xmlns="" id="{A83054AC-DBD0-4C20-A9E8-E120EB3F2FD1}"/>
              </a:ext>
            </a:extLst>
          </p:cNvPr>
          <p:cNvSpPr txBox="1"/>
          <p:nvPr/>
        </p:nvSpPr>
        <p:spPr>
          <a:xfrm>
            <a:off x="6124400" y="5264109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xmlns="" id="{60E52E61-5FB3-4538-AB6A-A472806E0199}"/>
              </a:ext>
            </a:extLst>
          </p:cNvPr>
          <p:cNvSpPr txBox="1"/>
          <p:nvPr/>
        </p:nvSpPr>
        <p:spPr>
          <a:xfrm>
            <a:off x="6124400" y="5146244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xmlns="" id="{5BF5E97F-D8A6-48CF-BF0B-2F2C35E4F6FD}"/>
              </a:ext>
            </a:extLst>
          </p:cNvPr>
          <p:cNvSpPr txBox="1"/>
          <p:nvPr/>
        </p:nvSpPr>
        <p:spPr>
          <a:xfrm>
            <a:off x="6017806" y="4895988"/>
            <a:ext cx="489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47CB116C-71EC-4B13-ADB4-974FBD79079D}"/>
              </a:ext>
            </a:extLst>
          </p:cNvPr>
          <p:cNvSpPr txBox="1"/>
          <p:nvPr/>
        </p:nvSpPr>
        <p:spPr>
          <a:xfrm>
            <a:off x="6068650" y="4656638"/>
            <a:ext cx="438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xmlns="" id="{BCF168B1-BBC6-4D25-B298-13F38811CA62}"/>
              </a:ext>
            </a:extLst>
          </p:cNvPr>
          <p:cNvSpPr txBox="1"/>
          <p:nvPr/>
        </p:nvSpPr>
        <p:spPr>
          <a:xfrm>
            <a:off x="8303137" y="5766852"/>
            <a:ext cx="9003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1bp </a:t>
            </a:r>
            <a:endParaRPr lang="en-I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HPV18 E6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729B1285-966A-4CC6-8158-5F692ED4122A}"/>
              </a:ext>
            </a:extLst>
          </p:cNvPr>
          <p:cNvSpPr txBox="1"/>
          <p:nvPr/>
        </p:nvSpPr>
        <p:spPr>
          <a:xfrm flipV="1">
            <a:off x="8230374" y="5751463"/>
            <a:ext cx="2498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►</a:t>
            </a:r>
            <a:endParaRPr lang="en-US" sz="11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85D59426-630A-4E43-B7F5-5B84771A304C}"/>
              </a:ext>
            </a:extLst>
          </p:cNvPr>
          <p:cNvSpPr txBox="1"/>
          <p:nvPr/>
        </p:nvSpPr>
        <p:spPr>
          <a:xfrm rot="16200000">
            <a:off x="6882734" y="309954"/>
            <a:ext cx="1311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64E1071B-6748-4CB5-975F-661AD788398C}"/>
              </a:ext>
            </a:extLst>
          </p:cNvPr>
          <p:cNvSpPr txBox="1"/>
          <p:nvPr/>
        </p:nvSpPr>
        <p:spPr>
          <a:xfrm rot="16200000">
            <a:off x="6790893" y="534089"/>
            <a:ext cx="862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BE29503E-665A-4216-B094-FD91D07C3E3B}"/>
              </a:ext>
            </a:extLst>
          </p:cNvPr>
          <p:cNvSpPr txBox="1"/>
          <p:nvPr/>
        </p:nvSpPr>
        <p:spPr>
          <a:xfrm rot="16200000">
            <a:off x="7162954" y="299209"/>
            <a:ext cx="133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BD2DFE16-BAA2-4498-9E29-0309737818D3}"/>
              </a:ext>
            </a:extLst>
          </p:cNvPr>
          <p:cNvSpPr txBox="1"/>
          <p:nvPr/>
        </p:nvSpPr>
        <p:spPr>
          <a:xfrm rot="16200000">
            <a:off x="6456653" y="497473"/>
            <a:ext cx="936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H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IN"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620111B4-472D-4120-8A2C-FAB8D446875F}"/>
              </a:ext>
            </a:extLst>
          </p:cNvPr>
          <p:cNvSpPr txBox="1"/>
          <p:nvPr/>
        </p:nvSpPr>
        <p:spPr>
          <a:xfrm rot="16200000">
            <a:off x="5734899" y="384263"/>
            <a:ext cx="11625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p Ladder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83B89AF0-02DA-4486-88F5-30FF745E7C20}"/>
              </a:ext>
            </a:extLst>
          </p:cNvPr>
          <p:cNvSpPr txBox="1"/>
          <p:nvPr/>
        </p:nvSpPr>
        <p:spPr>
          <a:xfrm rot="16200000">
            <a:off x="6212577" y="551022"/>
            <a:ext cx="82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C33a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95924337-C895-4253-BE55-2A387B93814D}"/>
              </a:ext>
            </a:extLst>
          </p:cNvPr>
          <p:cNvSpPr txBox="1"/>
          <p:nvPr/>
        </p:nvSpPr>
        <p:spPr>
          <a:xfrm>
            <a:off x="5836636" y="2756979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xmlns="" id="{9AE058BC-5AD6-44B3-B73A-6C061756E7E0}"/>
              </a:ext>
            </a:extLst>
          </p:cNvPr>
          <p:cNvSpPr txBox="1"/>
          <p:nvPr/>
        </p:nvSpPr>
        <p:spPr>
          <a:xfrm>
            <a:off x="5805075" y="2598151"/>
            <a:ext cx="4141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8CCA8AAC-C43A-46F3-AAFC-6F25F54F0102}"/>
              </a:ext>
            </a:extLst>
          </p:cNvPr>
          <p:cNvSpPr txBox="1"/>
          <p:nvPr/>
        </p:nvSpPr>
        <p:spPr>
          <a:xfrm>
            <a:off x="5836636" y="2481915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26C558F6-CA06-4BBA-8D60-BFCBB82456A6}"/>
              </a:ext>
            </a:extLst>
          </p:cNvPr>
          <p:cNvSpPr txBox="1"/>
          <p:nvPr/>
        </p:nvSpPr>
        <p:spPr>
          <a:xfrm>
            <a:off x="5749558" y="2361527"/>
            <a:ext cx="469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6A60642C-7015-4AE4-8BB3-85FC9C6D8F70}"/>
              </a:ext>
            </a:extLst>
          </p:cNvPr>
          <p:cNvSpPr txBox="1"/>
          <p:nvPr/>
        </p:nvSpPr>
        <p:spPr>
          <a:xfrm>
            <a:off x="5836636" y="2255410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473D6D71-13EF-44FA-AEBA-54B6798EDCD0}"/>
              </a:ext>
            </a:extLst>
          </p:cNvPr>
          <p:cNvSpPr txBox="1"/>
          <p:nvPr/>
        </p:nvSpPr>
        <p:spPr>
          <a:xfrm>
            <a:off x="5684236" y="1843399"/>
            <a:ext cx="534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9D13E2F2-ED5B-44AF-AE43-F9B470BFB319}"/>
              </a:ext>
            </a:extLst>
          </p:cNvPr>
          <p:cNvSpPr txBox="1"/>
          <p:nvPr/>
        </p:nvSpPr>
        <p:spPr>
          <a:xfrm>
            <a:off x="5836636" y="214485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338970E1-75CA-410A-8480-EC37DF77B97D}"/>
              </a:ext>
            </a:extLst>
          </p:cNvPr>
          <p:cNvSpPr txBox="1"/>
          <p:nvPr/>
        </p:nvSpPr>
        <p:spPr>
          <a:xfrm>
            <a:off x="5836636" y="2059893"/>
            <a:ext cx="382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1C891964-AC99-486C-94A6-C8B92B62DF7E}"/>
              </a:ext>
            </a:extLst>
          </p:cNvPr>
          <p:cNvSpPr txBox="1"/>
          <p:nvPr/>
        </p:nvSpPr>
        <p:spPr>
          <a:xfrm>
            <a:off x="5730042" y="1634930"/>
            <a:ext cx="489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7972DDCE-198F-496D-B667-AFEF73352F4F}"/>
              </a:ext>
            </a:extLst>
          </p:cNvPr>
          <p:cNvSpPr txBox="1"/>
          <p:nvPr/>
        </p:nvSpPr>
        <p:spPr>
          <a:xfrm>
            <a:off x="5780886" y="1437124"/>
            <a:ext cx="4382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7FCEAA8B-34E0-4EF8-AF67-7B7669DF9819}"/>
              </a:ext>
            </a:extLst>
          </p:cNvPr>
          <p:cNvSpPr txBox="1"/>
          <p:nvPr/>
        </p:nvSpPr>
        <p:spPr>
          <a:xfrm>
            <a:off x="8103275" y="2042146"/>
            <a:ext cx="10407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720bp </a:t>
            </a:r>
            <a:endParaRPr lang="en-I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oplasma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2DFE0AB7-D45F-4E90-8CED-8ED5915EFF42}"/>
              </a:ext>
            </a:extLst>
          </p:cNvPr>
          <p:cNvSpPr txBox="1"/>
          <p:nvPr/>
        </p:nvSpPr>
        <p:spPr>
          <a:xfrm flipV="1">
            <a:off x="7998688" y="2039165"/>
            <a:ext cx="2498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►</a:t>
            </a:r>
            <a:endParaRPr lang="en-US" sz="1100" dirty="0"/>
          </a:p>
        </p:txBody>
      </p:sp>
      <p:pic>
        <p:nvPicPr>
          <p:cNvPr id="138" name="Picture 137">
            <a:extLst>
              <a:ext uri="{FF2B5EF4-FFF2-40B4-BE49-F238E27FC236}">
                <a16:creationId xmlns:a16="http://schemas.microsoft.com/office/drawing/2014/main" xmlns="" id="{942BA9E0-0D0F-43F1-AD4C-B9F7EB9078C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18" t="45329" r="7768" b="30442"/>
          <a:stretch/>
        </p:blipFill>
        <p:spPr>
          <a:xfrm>
            <a:off x="6138026" y="1014304"/>
            <a:ext cx="1883210" cy="2000955"/>
          </a:xfrm>
          <a:prstGeom prst="rect">
            <a:avLst/>
          </a:prstGeom>
          <a:ln w="88900" cap="sq" cmpd="thickThin">
            <a:noFill/>
            <a:prstDash val="solid"/>
            <a:miter lim="800000"/>
          </a:ln>
          <a:effectLst>
            <a:innerShdw blurRad="76200">
              <a:srgbClr val="000000"/>
            </a:innerShdw>
          </a:effectLst>
        </p:spPr>
      </p:pic>
      <p:sp>
        <p:nvSpPr>
          <p:cNvPr id="3" name="Rectangle 2"/>
          <p:cNvSpPr/>
          <p:nvPr/>
        </p:nvSpPr>
        <p:spPr>
          <a:xfrm>
            <a:off x="8620156" y="-1791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SF1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079587" y="265414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lang="en-US" dirty="0"/>
          </a:p>
        </p:txBody>
      </p:sp>
      <p:cxnSp>
        <p:nvCxnSpPr>
          <p:cNvPr id="25" name="Straight Connector 24"/>
          <p:cNvCxnSpPr/>
          <p:nvPr/>
        </p:nvCxnSpPr>
        <p:spPr>
          <a:xfrm flipH="1" flipV="1">
            <a:off x="1016464" y="582449"/>
            <a:ext cx="9502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Rectangle 140"/>
          <p:cNvSpPr/>
          <p:nvPr/>
        </p:nvSpPr>
        <p:spPr>
          <a:xfrm>
            <a:off x="32275" y="6376211"/>
            <a:ext cx="911172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ure SF1: Cell line cross-contamination test.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NA isolated from cervical cancer cells (</a:t>
            </a:r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was subjected to PCR-based detection.  (B)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, (C) Mycoplasma, (D) HPV L1, (E) HPV16 E6 and (F) HPV18 E6.</a:t>
            </a:r>
            <a:endParaRPr lang="en-US" sz="1000" dirty="0"/>
          </a:p>
        </p:txBody>
      </p:sp>
      <p:sp>
        <p:nvSpPr>
          <p:cNvPr id="39" name="Rectangle 38"/>
          <p:cNvSpPr/>
          <p:nvPr/>
        </p:nvSpPr>
        <p:spPr>
          <a:xfrm>
            <a:off x="119586" y="23443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/>
          </a:p>
        </p:txBody>
      </p:sp>
      <p:sp>
        <p:nvSpPr>
          <p:cNvPr id="142" name="Rectangle 141"/>
          <p:cNvSpPr/>
          <p:nvPr/>
        </p:nvSpPr>
        <p:spPr>
          <a:xfrm>
            <a:off x="2603783" y="23443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/>
          </a:p>
        </p:txBody>
      </p:sp>
      <p:sp>
        <p:nvSpPr>
          <p:cNvPr id="143" name="Rectangle 142"/>
          <p:cNvSpPr/>
          <p:nvPr/>
        </p:nvSpPr>
        <p:spPr>
          <a:xfrm>
            <a:off x="5740135" y="23443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/>
          </a:p>
        </p:txBody>
      </p:sp>
      <p:sp>
        <p:nvSpPr>
          <p:cNvPr id="144" name="Rectangle 143"/>
          <p:cNvSpPr/>
          <p:nvPr/>
        </p:nvSpPr>
        <p:spPr>
          <a:xfrm>
            <a:off x="115997" y="3538467"/>
            <a:ext cx="3585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/>
          </a:p>
        </p:txBody>
      </p:sp>
      <p:sp>
        <p:nvSpPr>
          <p:cNvPr id="145" name="Rectangle 144"/>
          <p:cNvSpPr/>
          <p:nvPr/>
        </p:nvSpPr>
        <p:spPr>
          <a:xfrm>
            <a:off x="2600325" y="3519417"/>
            <a:ext cx="3454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/>
          </a:p>
        </p:txBody>
      </p:sp>
      <p:sp>
        <p:nvSpPr>
          <p:cNvPr id="146" name="Rectangle 145"/>
          <p:cNvSpPr/>
          <p:nvPr/>
        </p:nvSpPr>
        <p:spPr>
          <a:xfrm>
            <a:off x="5740135" y="3503855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4413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7201B355-431C-4142-A06D-7B3EA26E25FB}"/>
              </a:ext>
            </a:extLst>
          </p:cNvPr>
          <p:cNvSpPr txBox="1"/>
          <p:nvPr/>
        </p:nvSpPr>
        <p:spPr>
          <a:xfrm>
            <a:off x="0" y="1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equences of primers used for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haracterization/authentication of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ervical cancer cell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es and determination of mycoplasma contamination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xmlns="" id="{5BC3D256-6880-4AA3-8CF5-F26FD73D42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5546208"/>
              </p:ext>
            </p:extLst>
          </p:nvPr>
        </p:nvGraphicFramePr>
        <p:xfrm>
          <a:off x="142871" y="940905"/>
          <a:ext cx="8858259" cy="5837182"/>
        </p:xfrm>
        <a:graphic>
          <a:graphicData uri="http://schemas.openxmlformats.org/drawingml/2006/table">
            <a:tbl>
              <a:tblPr firstRow="1" bandRow="1">
                <a:tableStyleId>{793D81CF-94F2-401A-BA57-92F5A7B2D0C5}</a:tableStyleId>
              </a:tblPr>
              <a:tblGrid>
                <a:gridCol w="2952753">
                  <a:extLst>
                    <a:ext uri="{9D8B030D-6E8A-4147-A177-3AD203B41FA5}">
                      <a16:colId xmlns:a16="http://schemas.microsoft.com/office/drawing/2014/main" xmlns="" val="1256218809"/>
                    </a:ext>
                  </a:extLst>
                </a:gridCol>
                <a:gridCol w="1117870">
                  <a:extLst>
                    <a:ext uri="{9D8B030D-6E8A-4147-A177-3AD203B41FA5}">
                      <a16:colId xmlns:a16="http://schemas.microsoft.com/office/drawing/2014/main" xmlns="" val="3873216568"/>
                    </a:ext>
                  </a:extLst>
                </a:gridCol>
                <a:gridCol w="4787636">
                  <a:extLst>
                    <a:ext uri="{9D8B030D-6E8A-4147-A177-3AD203B41FA5}">
                      <a16:colId xmlns:a16="http://schemas.microsoft.com/office/drawing/2014/main" xmlns="" val="1227533801"/>
                    </a:ext>
                  </a:extLst>
                </a:gridCol>
              </a:tblGrid>
              <a:tr h="411611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839916361"/>
                  </a:ext>
                </a:extLst>
              </a:tr>
              <a:tr h="132268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ß-act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 CCA GCC AGG TCC AGA C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5353071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 GGC ACC AGG GCG TGA T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71023372"/>
                  </a:ext>
                </a:extLst>
              </a:tr>
              <a:tr h="133404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oplas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 CCT ACG GGA GGC AGC AGT 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2273252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 ACC ATC TGT CAC TCT GTT AAC CTC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4983816"/>
                  </a:ext>
                </a:extLst>
              </a:tr>
              <a:tr h="193474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n-NO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 CCC AAA GGA AAC TGA </a:t>
                      </a:r>
                      <a:r>
                        <a:rPr lang="nn-NO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 CCT AAA GGA AAC TGA T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 CCA AAA GGA AAC TGA T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AAG GGG AAA CTG AT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 CCC AAA GGA TAC TGA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T CCA AGG GGA TAC TGA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A CCT AAA GGG AAT TGA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A CCT AGT GGA AAT TGA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A CCA AGG GGA TAT TGA T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CAA CGG AAA CTG A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A CCC AAG GGA AAC TGG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T CCT AAA GGA AAC TGG TC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 ACC CAA TGC AAA TTG GT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26939946"/>
                  </a:ext>
                </a:extLst>
              </a:tr>
              <a:tr h="411611">
                <a:tc>
                  <a:txBody>
                    <a:bodyPr/>
                    <a:lstStyle/>
                    <a:p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 CAG GGA CAT AAC AAT 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 CAG GGC CAC AAT </a:t>
                      </a:r>
                      <a:r>
                        <a:rPr lang="en-US" sz="1100" kern="1200" dirty="0" err="1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T</a:t>
                      </a:r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G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 CAG GGA CAT AAT </a:t>
                      </a:r>
                      <a:r>
                        <a:rPr lang="en-US" sz="1100" kern="1200" dirty="0" err="1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T</a:t>
                      </a:r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G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C CAG GGC CAC AAC AAT GG</a:t>
                      </a:r>
                    </a:p>
                    <a:p>
                      <a:r>
                        <a:rPr lang="en-US" sz="110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T CAG GGT TTA AAC AAT GG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641916747"/>
                  </a:ext>
                </a:extLst>
              </a:tr>
              <a:tr h="239652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V16 E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 ACC GGT TAG TAT AAA AGC AGA 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18923832"/>
                  </a:ext>
                </a:extLst>
              </a:tr>
              <a:tr h="132208">
                <a:tc>
                  <a:txBody>
                    <a:bodyPr/>
                    <a:lstStyle/>
                    <a:p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 TGG GTT TCT CTA CGT GTT 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602529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V18 E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 GTA TGG AGA CAC ATT G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86340679"/>
                  </a:ext>
                </a:extLst>
              </a:tr>
              <a:tr h="411611">
                <a:tc>
                  <a:txBody>
                    <a:bodyPr/>
                    <a:lstStyle/>
                    <a:p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 GTG CCA AGC TAT GTT G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199865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85991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03780" y="1816120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rber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 descr="e6_berbamine.png"/>
          <p:cNvPicPr preferRelativeResize="0"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12500" b="73661" l="33857" r="75480"/>
                    </a14:imgEffect>
                  </a14:imgLayer>
                </a14:imgProps>
              </a:ext>
            </a:extLst>
          </a:blip>
          <a:srcRect l="41666" t="22288" r="30000" b="30815"/>
          <a:stretch>
            <a:fillRect/>
          </a:stretch>
        </p:blipFill>
        <p:spPr>
          <a:xfrm>
            <a:off x="2372844" y="212596"/>
            <a:ext cx="2157984" cy="150876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363700" y="1816120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rbam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22301" y="1816120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Hydrastine</a:t>
            </a:r>
          </a:p>
        </p:txBody>
      </p:sp>
      <p:pic>
        <p:nvPicPr>
          <p:cNvPr id="19" name="Picture 18" descr="e6_jotrorrhizine.png"/>
          <p:cNvPicPr preferRelativeResize="0"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23661" b="83036" l="36562" r="73037"/>
                    </a14:imgEffect>
                  </a14:imgLayer>
                </a14:imgProps>
              </a:ext>
            </a:extLst>
          </a:blip>
          <a:srcRect l="40000" t="30815" r="35000" b="22288"/>
          <a:stretch>
            <a:fillRect/>
          </a:stretch>
        </p:blipFill>
        <p:spPr>
          <a:xfrm>
            <a:off x="6880399" y="212596"/>
            <a:ext cx="2157984" cy="150876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6871255" y="1816120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atrorrhiz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 descr="e6_magonoflorine.png"/>
          <p:cNvPicPr preferRelativeResize="0"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5179" b="83259" l="30803" r="65532"/>
                    </a14:imgEffect>
                  </a14:imgLayer>
                </a14:imgProps>
              </a:ext>
            </a:extLst>
          </a:blip>
          <a:srcRect l="37500" t="20156" r="37500" b="26551"/>
          <a:stretch>
            <a:fillRect/>
          </a:stretch>
        </p:blipFill>
        <p:spPr>
          <a:xfrm>
            <a:off x="112924" y="2323694"/>
            <a:ext cx="2157984" cy="150876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03780" y="3925785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gnoflor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 descr="e6_oxycanthine.png"/>
          <p:cNvPicPr preferRelativeResize="0"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21652" b="85045" l="39180" r="69634"/>
                    </a14:imgEffect>
                  </a14:imgLayer>
                </a14:imgProps>
              </a:ext>
            </a:extLst>
          </a:blip>
          <a:srcRect l="43334" t="24420" r="33333" b="24420"/>
          <a:stretch>
            <a:fillRect/>
          </a:stretch>
        </p:blipFill>
        <p:spPr>
          <a:xfrm>
            <a:off x="2372844" y="2323694"/>
            <a:ext cx="2157984" cy="150876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2363700" y="3925785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ycanth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 descr="e6_columbamine.png"/>
          <p:cNvPicPr preferRelativeResize="0"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13839" b="72768" l="44503" r="84468"/>
                    </a14:imgEffect>
                  </a14:imgLayer>
                </a14:imgProps>
              </a:ext>
            </a:extLst>
          </a:blip>
          <a:srcRect l="47500" t="24420" r="23333" b="32946"/>
          <a:stretch>
            <a:fillRect/>
          </a:stretch>
        </p:blipFill>
        <p:spPr>
          <a:xfrm>
            <a:off x="4631445" y="2323694"/>
            <a:ext cx="2157984" cy="150876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4580661" y="3925785"/>
            <a:ext cx="225955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lumbam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 descr="e6_obamigine.png"/>
          <p:cNvPicPr preferRelativeResize="0">
            <a:picLocks/>
          </p:cNvPicPr>
          <p:nvPr/>
        </p:nvPicPr>
        <p:blipFill>
          <a:blip r:embed="rId12">
            <a:lum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670" b="63616" l="40140" r="72688"/>
                    </a14:imgEffect>
                  </a14:imgLayer>
                </a14:imgProps>
              </a:ext>
            </a:extLst>
          </a:blip>
          <a:srcRect l="42500" t="13761" r="33333" b="39342"/>
          <a:stretch>
            <a:fillRect/>
          </a:stretch>
        </p:blipFill>
        <p:spPr>
          <a:xfrm>
            <a:off x="6880399" y="2323694"/>
            <a:ext cx="2157984" cy="150876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6871255" y="3925785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amig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 descr="e6_aromoline.png"/>
          <p:cNvPicPr preferRelativeResize="0">
            <a:picLocks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33259" b="81696" l="34206" r="64747"/>
                    </a14:imgEffect>
                  </a14:imgLayer>
                </a14:imgProps>
              </a:ext>
            </a:extLst>
          </a:blip>
          <a:srcRect l="36666" t="35078" r="39167" b="22288"/>
          <a:stretch>
            <a:fillRect/>
          </a:stretch>
        </p:blipFill>
        <p:spPr>
          <a:xfrm>
            <a:off x="112924" y="4432938"/>
            <a:ext cx="2157984" cy="150876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03780" y="6035451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omal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32" descr="palamatine_CID.png"/>
          <p:cNvPicPr preferRelativeResize="0">
            <a:picLocks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1786" b="52902" l="36911" r="63438"/>
                    </a14:imgEffect>
                  </a14:imgLayer>
                </a14:imgProps>
              </a:ext>
            </a:extLst>
          </a:blip>
          <a:srcRect l="37500" r="35937" b="47963"/>
          <a:stretch>
            <a:fillRect/>
          </a:stretch>
        </p:blipFill>
        <p:spPr>
          <a:xfrm>
            <a:off x="2372844" y="4432938"/>
            <a:ext cx="2157984" cy="150876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2363700" y="6035451"/>
            <a:ext cx="2176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lmat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 descr="6SJA_chainb.png"/>
          <p:cNvPicPr preferRelativeResize="0">
            <a:picLocks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ackgroundRemoval t="30134" b="99554" l="34468" r="65969"/>
                    </a14:imgEffect>
                  </a14:imgLayer>
                </a14:imgProps>
              </a:ext>
            </a:extLst>
          </a:blip>
          <a:srcRect l="39062" t="37971" r="37500" b="18062"/>
          <a:stretch>
            <a:fillRect/>
          </a:stretch>
        </p:blipFill>
        <p:spPr>
          <a:xfrm>
            <a:off x="6880399" y="4432938"/>
            <a:ext cx="2157984" cy="1508760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6774782" y="6035451"/>
            <a:ext cx="236921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 (6SJA_Chain_B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8370715" y="-32266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F2A</a:t>
            </a:r>
          </a:p>
        </p:txBody>
      </p:sp>
      <p:pic>
        <p:nvPicPr>
          <p:cNvPr id="31" name="Picture 3" descr="C:\Users\LENOVO\Documents\Tejveer Guru\doking\HC_Pymol_files\K91Berberine_6SJA.png"/>
          <p:cNvPicPr preferRelativeResize="0">
            <a:picLocks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16" t="12500" r="27915" b="8604"/>
          <a:stretch/>
        </p:blipFill>
        <p:spPr bwMode="auto">
          <a:xfrm>
            <a:off x="107504" y="212956"/>
            <a:ext cx="2156400" cy="150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4" descr="C:\Users\LENOVO\Documents\Tejveer Guru\doking\HC_Pymol_files\K93Hydrastine_6SJA.png"/>
          <p:cNvPicPr preferRelativeResize="0">
            <a:picLocks noChangeArrowheads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16" t="12500" r="30835" b="15747"/>
          <a:stretch/>
        </p:blipFill>
        <p:spPr bwMode="auto">
          <a:xfrm>
            <a:off x="4631445" y="212956"/>
            <a:ext cx="2156400" cy="150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Rectangle 31"/>
          <p:cNvSpPr/>
          <p:nvPr/>
        </p:nvSpPr>
        <p:spPr>
          <a:xfrm>
            <a:off x="-32028" y="6222654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Molecular docking of key phytochemicals reported in </a:t>
            </a:r>
            <a:r>
              <a:rPr lang="en-US" sz="10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. </a:t>
            </a:r>
            <a:r>
              <a:rPr lang="en-US" sz="1000" b="1" i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quifolium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root with HPV16 E6 </a:t>
            </a:r>
            <a:r>
              <a:rPr 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(B chain of 6SJA). </a:t>
            </a:r>
            <a:r>
              <a:rPr lang="en-US" sz="10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Molecular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rface structures of the best ranked docking pose of HPV16 </a:t>
            </a:r>
            <a:r>
              <a:rPr lang="en-US" sz="10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howing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nteracting sites of phytochemicals generated using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yMOL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. The protein-ligand complex .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db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file was opened in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yMOL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and different viewing options were selected for E6 protein (molecular surface, Green) and phytochemical ligand (sticks; Red). The binding pocket residues were selected and viewed in Blue. Empty E6 molecular structure is shown on bottom right of each panel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888442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369110" y="1828819"/>
            <a:ext cx="2157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rbam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2837" y="3938484"/>
            <a:ext cx="22203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gnoflor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882581" y="3938484"/>
            <a:ext cx="2157984" cy="3071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amig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 descr="N401berbamine_CID_275182.png"/>
          <p:cNvPicPr preferRelativeResize="0"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39373" t="15570" r="19941" b="15528"/>
          <a:stretch>
            <a:fillRect/>
          </a:stretch>
        </p:blipFill>
        <p:spPr>
          <a:xfrm>
            <a:off x="2369110" y="226250"/>
            <a:ext cx="2157984" cy="1508760"/>
          </a:xfrm>
          <a:prstGeom prst="rect">
            <a:avLst/>
          </a:prstGeom>
        </p:spPr>
      </p:pic>
      <p:pic>
        <p:nvPicPr>
          <p:cNvPr id="34" name="Picture 33" descr="N406magnoflorine_con1.png"/>
          <p:cNvPicPr preferRelativeResize="0"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29822" t="13565" r="29775" b="13704"/>
          <a:stretch>
            <a:fillRect/>
          </a:stretch>
        </p:blipFill>
        <p:spPr>
          <a:xfrm>
            <a:off x="114039" y="2336393"/>
            <a:ext cx="2157984" cy="1508760"/>
          </a:xfrm>
          <a:prstGeom prst="rect">
            <a:avLst/>
          </a:prstGeom>
        </p:spPr>
      </p:pic>
      <p:pic>
        <p:nvPicPr>
          <p:cNvPr id="41" name="Picture 40" descr="N407Obamegine_conf2.png"/>
          <p:cNvPicPr preferRelativeResize="0"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28583" t="9958" r="29789" b="21139"/>
          <a:stretch>
            <a:fillRect/>
          </a:stretch>
        </p:blipFill>
        <p:spPr>
          <a:xfrm>
            <a:off x="6882581" y="2336393"/>
            <a:ext cx="2157984" cy="150876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14039" y="1828819"/>
            <a:ext cx="2157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rber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882581" y="1828819"/>
            <a:ext cx="2157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atrorrhiz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81696" y="3938484"/>
            <a:ext cx="226472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lumbam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 descr="N404Columbamine.png"/>
          <p:cNvPicPr preferRelativeResize="0"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30132" t="9958" r="29465" b="21139"/>
          <a:stretch>
            <a:fillRect/>
          </a:stretch>
        </p:blipFill>
        <p:spPr>
          <a:xfrm>
            <a:off x="4635066" y="2336393"/>
            <a:ext cx="2157984" cy="1508760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2369110" y="6048150"/>
            <a:ext cx="2157984" cy="307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lmat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 descr="N412Berberine_conf2.png"/>
          <p:cNvPicPr preferRelativeResize="0"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29777" t="10885" r="29537" b="20788"/>
          <a:stretch>
            <a:fillRect/>
          </a:stretch>
        </p:blipFill>
        <p:spPr>
          <a:xfrm>
            <a:off x="114039" y="226250"/>
            <a:ext cx="2157984" cy="1508760"/>
          </a:xfrm>
          <a:prstGeom prst="rect">
            <a:avLst/>
          </a:prstGeom>
        </p:spPr>
      </p:pic>
      <p:pic>
        <p:nvPicPr>
          <p:cNvPr id="27" name="Picture 26" descr="N405Jatrorrhizine_conf1.png"/>
          <p:cNvPicPr preferRelativeResize="0">
            <a:picLocks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0" b="100000" l="0" r="10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8295" t="16411" r="29465" b="14687"/>
          <a:stretch>
            <a:fillRect/>
          </a:stretch>
        </p:blipFill>
        <p:spPr>
          <a:xfrm>
            <a:off x="6882581" y="226250"/>
            <a:ext cx="2157984" cy="1508760"/>
          </a:xfrm>
          <a:prstGeom prst="rect">
            <a:avLst/>
          </a:prstGeom>
        </p:spPr>
      </p:pic>
      <p:pic>
        <p:nvPicPr>
          <p:cNvPr id="42" name="Picture 41" descr="N409palmatine_conf.png"/>
          <p:cNvPicPr preferRelativeResize="0"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ackgroundRemoval t="2389" b="100000" l="0" r="100000"/>
                    </a14:imgEffect>
                  </a14:imgLayer>
                </a14:imgProps>
              </a:ext>
            </a:extLst>
          </a:blip>
          <a:srcRect l="30132" t="19387" r="29465" b="14230"/>
          <a:stretch>
            <a:fillRect/>
          </a:stretch>
        </p:blipFill>
        <p:spPr>
          <a:xfrm>
            <a:off x="2369110" y="4445637"/>
            <a:ext cx="2157984" cy="150876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635066" y="1828819"/>
            <a:ext cx="2157984" cy="305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Hydrastine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69110" y="3938484"/>
            <a:ext cx="2157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xycanth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4039" y="6048150"/>
            <a:ext cx="2157984" cy="3062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: </a:t>
            </a:r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omaline</a:t>
            </a:r>
            <a:endParaRPr lang="en-US" sz="13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 descr="N408Oxyacanthin.png"/>
          <p:cNvPicPr preferRelativeResize="0">
            <a:picLocks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ackgroundRemoval t="1245" b="100000" l="162" r="100000"/>
                    </a14:imgEffect>
                  </a14:imgLayer>
                </a14:imgProps>
              </a:ext>
            </a:extLst>
          </a:blip>
          <a:srcRect l="30111" t="5780" r="29013" b="13834"/>
          <a:stretch>
            <a:fillRect/>
          </a:stretch>
        </p:blipFill>
        <p:spPr>
          <a:xfrm>
            <a:off x="2369110" y="2336393"/>
            <a:ext cx="2157984" cy="1508760"/>
          </a:xfrm>
          <a:prstGeom prst="rect">
            <a:avLst/>
          </a:prstGeom>
        </p:spPr>
      </p:pic>
      <p:pic>
        <p:nvPicPr>
          <p:cNvPr id="25" name="Picture 24" descr="N402aromoline_Conf 1.png"/>
          <p:cNvPicPr preferRelativeResize="0">
            <a:picLocks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ackgroundRemoval t="0" b="100000" l="0" r="96717"/>
                    </a14:imgEffect>
                  </a14:imgLayer>
                </a14:imgProps>
              </a:ext>
            </a:extLst>
          </a:blip>
          <a:srcRect l="31998" t="15002" r="29576" b="14467"/>
          <a:stretch>
            <a:fillRect/>
          </a:stretch>
        </p:blipFill>
        <p:spPr>
          <a:xfrm>
            <a:off x="114039" y="4445637"/>
            <a:ext cx="2157984" cy="1508760"/>
          </a:xfrm>
          <a:prstGeom prst="rect">
            <a:avLst/>
          </a:prstGeom>
        </p:spPr>
      </p:pic>
      <p:pic>
        <p:nvPicPr>
          <p:cNvPr id="43" name="Picture 42" descr="N410hydrastine_Conf3.png"/>
          <p:cNvPicPr preferRelativeResize="0">
            <a:picLocks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ackgroundRemoval t="0" b="100000" l="0" r="100000"/>
                    </a14:imgEffect>
                  </a14:imgLayer>
                </a14:imgProps>
              </a:ext>
            </a:extLst>
          </a:blip>
          <a:srcRect l="29923" t="16059" r="28449" b="5112"/>
          <a:stretch>
            <a:fillRect/>
          </a:stretch>
        </p:blipFill>
        <p:spPr>
          <a:xfrm>
            <a:off x="4635066" y="226250"/>
            <a:ext cx="2157984" cy="1508760"/>
          </a:xfrm>
          <a:prstGeom prst="rect">
            <a:avLst/>
          </a:prstGeom>
        </p:spPr>
      </p:pic>
      <p:pic>
        <p:nvPicPr>
          <p:cNvPr id="30" name="Picture 29" descr="4XR8_chainF.png"/>
          <p:cNvPicPr preferRelativeResize="0">
            <a:picLocks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ackgroundRemoval t="26786" b="78795" l="40227" r="62042"/>
                    </a14:imgEffect>
                  </a14:imgLayer>
                </a14:imgProps>
              </a:ext>
            </a:extLst>
          </a:blip>
          <a:srcRect l="42187" t="31976" r="40625" b="32052"/>
          <a:stretch>
            <a:fillRect/>
          </a:stretch>
        </p:blipFill>
        <p:spPr>
          <a:xfrm>
            <a:off x="6882581" y="4445637"/>
            <a:ext cx="2157984" cy="150876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6788673" y="6048150"/>
            <a:ext cx="23458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V16 E6 (4XR8_Chain_F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8369429" y="-262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F2B</a:t>
            </a:r>
          </a:p>
        </p:txBody>
      </p:sp>
      <p:sp>
        <p:nvSpPr>
          <p:cNvPr id="28" name="Rectangle 27"/>
          <p:cNvSpPr/>
          <p:nvPr/>
        </p:nvSpPr>
        <p:spPr>
          <a:xfrm>
            <a:off x="-33617" y="628685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Molecular docking of key phytochemicals reported in </a:t>
            </a:r>
            <a:r>
              <a:rPr lang="en-US" sz="9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. </a:t>
            </a:r>
            <a:r>
              <a:rPr lang="en-US" sz="900" b="1" i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quifolium</a:t>
            </a:r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root with HPV16 E6 </a:t>
            </a:r>
            <a:r>
              <a:rPr lang="en-US" sz="900" b="1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(F chain of 4RX8).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Molecular 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rface structures of the best ranked docking pose of HPV16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howing 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nteracting sites of phytochemicals generated using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yMOL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. The protein-ligand complex .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db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file was opened in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yMOL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and different viewing options were selected for E6 protein (molecular surface, Green) and phytochemical ligand (sticks; Red). The binding pocket residues were selected and viewed in Blue. Empty E6 molecular structure is shown on bottom right of each panel</a:t>
            </a:r>
            <a:endParaRPr lang="en-US" sz="9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3</TotalTime>
  <Words>721</Words>
  <Application>Microsoft Office PowerPoint</Application>
  <PresentationFormat>On-screen Show (4:3)</PresentationFormat>
  <Paragraphs>18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 S Gurjar</dc:creator>
  <cp:lastModifiedBy>Microsoft account</cp:lastModifiedBy>
  <cp:revision>64</cp:revision>
  <dcterms:created xsi:type="dcterms:W3CDTF">2006-08-16T00:00:00Z</dcterms:created>
  <dcterms:modified xsi:type="dcterms:W3CDTF">2021-10-09T16:25:19Z</dcterms:modified>
</cp:coreProperties>
</file>